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35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88E6F-9271-44E3-8A00-3AEED242D614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5435F2-8B4A-4996-AD76-663B37555D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292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448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0947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098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403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710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677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520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35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5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21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928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040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1005041"/>
              </p:ext>
            </p:extLst>
          </p:nvPr>
        </p:nvGraphicFramePr>
        <p:xfrm>
          <a:off x="539552" y="1196752"/>
          <a:ext cx="7848872" cy="5102027"/>
        </p:xfrm>
        <a:graphic>
          <a:graphicData uri="http://schemas.openxmlformats.org/drawingml/2006/table">
            <a:tbl>
              <a:tblPr firstRow="1" firstCol="1" bandRow="1"/>
              <a:tblGrid>
                <a:gridCol w="555395"/>
                <a:gridCol w="1028781"/>
                <a:gridCol w="504056"/>
                <a:gridCol w="504056"/>
                <a:gridCol w="432048"/>
                <a:gridCol w="576064"/>
                <a:gridCol w="504056"/>
                <a:gridCol w="432048"/>
                <a:gridCol w="504056"/>
                <a:gridCol w="432048"/>
                <a:gridCol w="504056"/>
                <a:gridCol w="432048"/>
                <a:gridCol w="504056"/>
                <a:gridCol w="432048"/>
                <a:gridCol w="504056"/>
              </a:tblGrid>
              <a:tr h="279163">
                <a:tc rowSpan="2" gridSpan="2">
                  <a:txBody>
                    <a:bodyPr/>
                    <a:lstStyle/>
                    <a:p>
                      <a:endParaRPr lang="zh-CN" sz="1000" kern="100" dirty="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1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Times New Roman"/>
                        </a:rPr>
                        <a:t>Amino acid identity</a:t>
                      </a:r>
                      <a:endParaRPr lang="zh-CN" sz="12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475430"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4834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11674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8993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28990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0805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8994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28989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30881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14170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05640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6121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09030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4121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rowSpan="1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ucleotide identity</a:t>
                      </a:r>
                      <a:endParaRPr lang="zh-CN" sz="12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vert="eaVert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4834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 dirty="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9.01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7.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3.1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7.8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2.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1.8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3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6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5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2.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6.0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5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11674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6.0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6.96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2.92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7.58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2.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1.8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4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4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2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2.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5.8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2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8993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2.88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2.2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2.05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9.3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7.5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7.16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7.52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6.1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3.8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4.5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4.7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28990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7.9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7.4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9.9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9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1.2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7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6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99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4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2.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6.0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7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0805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6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7.5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4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6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9.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9.7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9.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9.8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28.3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25.7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22.7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0.0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289940</a:t>
                      </a:r>
                      <a:endParaRPr lang="zh-CN" sz="10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8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3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6.2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7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1.4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8.01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0.8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0.8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8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1.5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5.7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9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28989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70.1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6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6.3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1.9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7.1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0.7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0.7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7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1.3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5.7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9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30881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9.2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8.1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3.8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8.4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4.1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4.2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/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8.52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1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7.5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14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14170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8.8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8.6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4.1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8.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4.4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4.5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97.9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5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4.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7.8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57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05640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4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0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9.0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3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2.8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0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1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2.3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2.5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2.72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3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3.65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6121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9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6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4.4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5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0.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3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6.4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7.8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0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84.28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3.3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7.79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syl009030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.5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.3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8.4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.2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26.4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.1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0.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1.1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1.1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36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5.1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4.73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41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Ntom0041210</a:t>
                      </a:r>
                      <a:endParaRPr lang="zh-CN" sz="10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0.77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0.4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48.23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0.7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34.22</a:t>
                      </a:r>
                      <a:endParaRPr lang="zh-CN" sz="1100" kern="100" dirty="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0.31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0.42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6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51.4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5.59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0.2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宋体"/>
                          <a:cs typeface="宋体"/>
                        </a:rPr>
                        <a:t>65.15</a:t>
                      </a:r>
                      <a:endParaRPr lang="zh-CN" sz="1100" kern="100">
                        <a:effectLst/>
                        <a:latin typeface="+mj-lt"/>
                        <a:ea typeface="宋体"/>
                        <a:cs typeface="Times New Roman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sz="1100" kern="100" dirty="0">
                        <a:effectLst/>
                        <a:latin typeface="+mj-lt"/>
                      </a:endParaRPr>
                    </a:p>
                  </a:txBody>
                  <a:tcPr marL="24652" marR="24652" marT="880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2700000" y="2024864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3150000" y="2358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3672000" y="2700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5148000" y="3708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6084000" y="4374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7012800" y="5040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2196000" y="2358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2700000" y="2700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3150000" y="3024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680000" y="4032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616000" y="4698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6552000" y="5364000"/>
            <a:ext cx="36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0" y="245849"/>
            <a:ext cx="9144000" cy="8788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Suppl. Table S2</a:t>
            </a:r>
            <a:r>
              <a:rPr lang="en-US" altLang="zh-CN" kern="100" dirty="0">
                <a:latin typeface="Times New Roman"/>
                <a:cs typeface="Times New Roman"/>
              </a:rPr>
              <a:t> Identity matrix of predicted </a:t>
            </a:r>
            <a:r>
              <a:rPr lang="en-US" altLang="zh-CN" kern="100" dirty="0" err="1">
                <a:latin typeface="Times New Roman"/>
                <a:cs typeface="Times New Roman"/>
              </a:rPr>
              <a:t>Sus</a:t>
            </a:r>
            <a:r>
              <a:rPr lang="en-US" altLang="zh-CN" kern="100" dirty="0">
                <a:latin typeface="Times New Roman"/>
                <a:cs typeface="Times New Roman"/>
              </a:rPr>
              <a:t> amino acid sequences and their coding sequences in </a:t>
            </a:r>
            <a:r>
              <a:rPr lang="en-US" altLang="zh-CN" i="1" kern="100" dirty="0" err="1">
                <a:latin typeface="Times New Roman"/>
                <a:cs typeface="Times New Roman"/>
              </a:rPr>
              <a:t>Nicotiana</a:t>
            </a:r>
            <a:r>
              <a:rPr lang="en-US" altLang="zh-CN" i="1" kern="100" dirty="0">
                <a:latin typeface="Times New Roman"/>
                <a:cs typeface="Times New Roman"/>
              </a:rPr>
              <a:t> </a:t>
            </a:r>
            <a:r>
              <a:rPr lang="en-US" altLang="zh-CN" i="1" kern="100" dirty="0" err="1">
                <a:latin typeface="Times New Roman"/>
                <a:cs typeface="Times New Roman"/>
              </a:rPr>
              <a:t>sylvestris</a:t>
            </a:r>
            <a:r>
              <a:rPr lang="en-US" altLang="zh-CN" kern="100" dirty="0">
                <a:latin typeface="Times New Roman"/>
                <a:cs typeface="Times New Roman"/>
              </a:rPr>
              <a:t> and </a:t>
            </a:r>
            <a:r>
              <a:rPr lang="en-US" altLang="zh-CN" i="1" kern="100" dirty="0" err="1">
                <a:latin typeface="Times New Roman"/>
                <a:cs typeface="Times New Roman"/>
              </a:rPr>
              <a:t>Nicotiana</a:t>
            </a:r>
            <a:r>
              <a:rPr lang="en-US" altLang="zh-CN" i="1" kern="100" dirty="0">
                <a:latin typeface="Times New Roman"/>
                <a:cs typeface="Times New Roman"/>
              </a:rPr>
              <a:t> </a:t>
            </a:r>
            <a:r>
              <a:rPr lang="en-US" altLang="zh-CN" i="1" kern="100" dirty="0" err="1">
                <a:latin typeface="Times New Roman"/>
                <a:cs typeface="Times New Roman"/>
              </a:rPr>
              <a:t>tomentosiformis</a:t>
            </a:r>
            <a:r>
              <a:rPr lang="en-US" altLang="zh-CN" kern="100" dirty="0">
                <a:latin typeface="Times New Roman"/>
                <a:cs typeface="Times New Roman"/>
              </a:rPr>
              <a:t>.</a:t>
            </a:r>
            <a:endParaRPr lang="zh-CN" altLang="zh-CN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492840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10</Words>
  <Application>Microsoft Office PowerPoint</Application>
  <PresentationFormat>全屏显示(4:3)</PresentationFormat>
  <Paragraphs>18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Jun</dc:creator>
  <cp:lastModifiedBy>YangJun</cp:lastModifiedBy>
  <cp:revision>18</cp:revision>
  <dcterms:created xsi:type="dcterms:W3CDTF">2015-03-27T09:07:30Z</dcterms:created>
  <dcterms:modified xsi:type="dcterms:W3CDTF">2015-03-27T09:24:39Z</dcterms:modified>
</cp:coreProperties>
</file>